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7" r:id="rId2"/>
    <p:sldId id="306" r:id="rId3"/>
    <p:sldId id="313" r:id="rId4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 showGuides="1">
      <p:cViewPr varScale="1">
        <p:scale>
          <a:sx n="69" d="100"/>
          <a:sy n="69" d="100"/>
        </p:scale>
        <p:origin x="79" y="98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ECD408-0267-E948-B3AA-068821B794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0246AD0-A642-D3BB-A3A4-193107DC7D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920DAE-1516-BCE6-03F6-BEC6497BF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E77D0F-B33A-0D3D-8A4B-7435065BB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2232CC-FF7F-DF15-20B8-AC51FEFCFB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7890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591545-1DE2-6F13-D996-BCB59FCAE6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EEB8DC1-5C2E-899B-664E-51487570FE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3EFB75-3832-603A-BA1A-F61CF4BC9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FCF0B0-4C13-BC63-50F8-7E70F6000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DC55E4A-2E30-1EF6-6AC0-BCECD529E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321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DD8042B-D5A0-2B68-FDDB-1B902E81DB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EA83232-BB38-CEEF-BF4C-744F6AC3EA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4A14BE-9902-BB86-7F06-C92BC71B3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45D3FD-2954-C94C-2EC0-987279028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BC2FCD-4EC3-8D5F-E52D-7BD05965E7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5863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415780-119F-B600-F352-F3740C7F3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5DE1619-53B4-2A23-B5E7-677848DA02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DEA62B-53E3-F7A6-993B-94C8291ED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6367643-37F8-57EA-26A0-2202D4AFC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CD42A4-796B-5258-67D6-8B9666A3C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7301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BDF20B-33B7-A11B-1264-36D2B4859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DCE2A23-D1E7-1DBF-A644-174138BE22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C1E08D-F950-0123-216C-34B209639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0CE9B1-2668-C840-5DE4-0219ED845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A68F5A-5C37-9F26-32F3-8469C87E7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076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6372E5-C7E5-7EFC-6943-05E51B546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DFD8293-AD6B-451D-FBD2-90102AB6A6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BFBF2DB-AD8D-532E-0898-D298B0F165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8DC3DD7-DABA-9F92-A735-AE214DC57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2BC416-1AF0-C0CB-E327-7FDE02B8F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83C003-D9CA-18FE-BEFC-8BDA8EA32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156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E0AD2F-F41E-7F2C-318D-EEEFF60E3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9AE517D-1C35-F160-4AEB-6BA194327B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CF72985-C1B0-C9BA-37C7-CEF3000C2F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9CF3646-0B06-D8ED-9C54-67AD1992A9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93C4C62-538D-55A8-A07E-ABAB8B71BB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6C3BA9B-8E8C-53D1-BD61-B5CF114AB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430EF2A-8709-5099-B421-4A42E4C88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9468B17-2C24-F31D-1DEF-2DE64131A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876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FAFFD1-82E4-8B58-4396-2B04F2B0C7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62F835E-EA64-A59C-F740-859FD0B1F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EAA7A9C-2E7D-CED5-150C-9BF7B4EB3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3A43533-E3AC-C78D-BEBF-BADB51854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81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1683044-1EAF-E5DB-A28B-D5BE682A5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65A2156-9AEB-C3B1-9597-62E7F9CDE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1E67195-A3D9-7FD2-5792-30C657AF6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626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A49625-D68B-0D67-F9E1-D08603413C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1927DB9-C537-3A04-BBD5-865157F186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4108CAA-07EE-DCB8-8945-8B31B62CE0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EB006C-F3CD-EB08-88B8-D67DB61CD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5EFB163-DF70-7EF7-BA54-AEB8CAC35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46A711-B876-E23D-1C06-DBF9B1D06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4120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A0F470-A19F-D67F-C281-515E0AD813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CD2A06F-3036-449B-2B00-838D52BF0B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D772C7F-3E07-55AA-BCAB-7261D680DC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98D054E-A841-2FD2-DF33-FF4EC08C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82465D-6D1F-5F95-370D-FBBF899E0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0E81C6-42B9-A43B-1078-E8A0910150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416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6FF8461-98FF-55EB-CD11-B5368BC7F5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CC7DD77-2B9C-440E-F75A-56213D343E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CA9232-2951-C8E1-9F30-B50507B3BB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EA757-F220-4C01-ABA3-415702584821}" type="datetimeFigureOut">
              <a:rPr kumimoji="1" lang="ja-JP" altLang="en-US" smtClean="0"/>
              <a:t>2022/11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22AB50-8F1E-969E-20E8-4CC61CF92D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99BB12-182B-35FE-8F6D-C18C93FDF8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65EBD-5B84-4132-9CFC-7FB2567451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319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5">
            <a:extLst>
              <a:ext uri="{FF2B5EF4-FFF2-40B4-BE49-F238E27FC236}">
                <a16:creationId xmlns:a16="http://schemas.microsoft.com/office/drawing/2014/main" id="{8198B3EE-4C42-5C4A-5122-4B13CEDC201A}"/>
              </a:ext>
            </a:extLst>
          </p:cNvPr>
          <p:cNvSpPr>
            <a:spLocks noChangeShapeType="1"/>
          </p:cNvSpPr>
          <p:nvPr/>
        </p:nvSpPr>
        <p:spPr bwMode="auto">
          <a:xfrm>
            <a:off x="3972478" y="3878743"/>
            <a:ext cx="2733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94421424-7E91-F3BB-E839-34868CDD9F32}"/>
              </a:ext>
            </a:extLst>
          </p:cNvPr>
          <p:cNvSpPr>
            <a:spLocks noChangeShapeType="1"/>
          </p:cNvSpPr>
          <p:nvPr/>
        </p:nvSpPr>
        <p:spPr bwMode="auto">
          <a:xfrm>
            <a:off x="3972478" y="3878743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D3AB38F8-665A-A08D-9187-D043B38BFCAD}"/>
              </a:ext>
            </a:extLst>
          </p:cNvPr>
          <p:cNvSpPr>
            <a:spLocks noChangeShapeType="1"/>
          </p:cNvSpPr>
          <p:nvPr/>
        </p:nvSpPr>
        <p:spPr bwMode="auto">
          <a:xfrm>
            <a:off x="4426503" y="3878743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DC505BF0-49EB-4072-41A8-01D170BD8014}"/>
              </a:ext>
            </a:extLst>
          </p:cNvPr>
          <p:cNvSpPr>
            <a:spLocks noChangeShapeType="1"/>
          </p:cNvSpPr>
          <p:nvPr/>
        </p:nvSpPr>
        <p:spPr bwMode="auto">
          <a:xfrm>
            <a:off x="4882116" y="3878743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DAADFFAF-C4B9-2A23-3B92-99E38DE07DB3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6141" y="3878743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0">
            <a:extLst>
              <a:ext uri="{FF2B5EF4-FFF2-40B4-BE49-F238E27FC236}">
                <a16:creationId xmlns:a16="http://schemas.microsoft.com/office/drawing/2014/main" id="{20CE2B9E-80B6-0AEA-6C69-C47143A51858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6516" y="3878743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701422BE-52B8-0915-4D9D-4E8AFCA1405C}"/>
              </a:ext>
            </a:extLst>
          </p:cNvPr>
          <p:cNvSpPr>
            <a:spLocks noChangeShapeType="1"/>
          </p:cNvSpPr>
          <p:nvPr/>
        </p:nvSpPr>
        <p:spPr bwMode="auto">
          <a:xfrm>
            <a:off x="6252128" y="3878743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12">
            <a:extLst>
              <a:ext uri="{FF2B5EF4-FFF2-40B4-BE49-F238E27FC236}">
                <a16:creationId xmlns:a16="http://schemas.microsoft.com/office/drawing/2014/main" id="{A37AE96C-57E1-6336-BA3E-468ADF6BD5E9}"/>
              </a:ext>
            </a:extLst>
          </p:cNvPr>
          <p:cNvSpPr>
            <a:spLocks noChangeShapeType="1"/>
          </p:cNvSpPr>
          <p:nvPr/>
        </p:nvSpPr>
        <p:spPr bwMode="auto">
          <a:xfrm>
            <a:off x="6706153" y="3878743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EADE2AE-E685-D5CF-11CB-F87A61AC32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26441" y="4000981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F65E318-0E1D-3C2B-3672-2B5B1A1F03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1891" y="4000981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C5A245D-4901-B0D4-9628-28F65D5C06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7503" y="4000981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22002B5-F688-1EB0-3349-DD8F9BD1BC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1528" y="4000981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BAD820A-75BE-F09A-C71A-A63826EA9B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1903" y="4000981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FFD5ABE-44F8-D933-8EDF-7A30AFB467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77516" y="4000981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DD452D3-3F47-3169-DCC5-DA38E3B525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1541" y="4000981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20">
            <a:extLst>
              <a:ext uri="{FF2B5EF4-FFF2-40B4-BE49-F238E27FC236}">
                <a16:creationId xmlns:a16="http://schemas.microsoft.com/office/drawing/2014/main" id="{1539B39F-1887-2FA0-F6B3-8A81C5B5B2C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61353" y="1359381"/>
            <a:ext cx="0" cy="241935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21">
            <a:extLst>
              <a:ext uri="{FF2B5EF4-FFF2-40B4-BE49-F238E27FC236}">
                <a16:creationId xmlns:a16="http://schemas.microsoft.com/office/drawing/2014/main" id="{C0206AC5-46C9-862A-11C2-1F57B921B79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02616" y="3778731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22">
            <a:extLst>
              <a:ext uri="{FF2B5EF4-FFF2-40B4-BE49-F238E27FC236}">
                <a16:creationId xmlns:a16="http://schemas.microsoft.com/office/drawing/2014/main" id="{E4A9562A-4D40-AC5F-EE29-5593B974149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02616" y="3294543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3">
            <a:extLst>
              <a:ext uri="{FF2B5EF4-FFF2-40B4-BE49-F238E27FC236}">
                <a16:creationId xmlns:a16="http://schemas.microsoft.com/office/drawing/2014/main" id="{A9716304-28E4-F36B-EB66-FCEA7273581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02616" y="2810356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4">
            <a:extLst>
              <a:ext uri="{FF2B5EF4-FFF2-40B4-BE49-F238E27FC236}">
                <a16:creationId xmlns:a16="http://schemas.microsoft.com/office/drawing/2014/main" id="{A68E8A1D-0548-E50A-301E-4DB8CF0998C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02616" y="2327756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25">
            <a:extLst>
              <a:ext uri="{FF2B5EF4-FFF2-40B4-BE49-F238E27FC236}">
                <a16:creationId xmlns:a16="http://schemas.microsoft.com/office/drawing/2014/main" id="{37A7A0EB-91E8-FBD9-C6B2-44D3A789D03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02616" y="1843568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6">
            <a:extLst>
              <a:ext uri="{FF2B5EF4-FFF2-40B4-BE49-F238E27FC236}">
                <a16:creationId xmlns:a16="http://schemas.microsoft.com/office/drawing/2014/main" id="{B883EAFD-FD66-7C4F-3A04-C329D821961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802616" y="1359381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0893473-EC47-B51E-DBEF-138C4427BA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2144" y="3692904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5279828-343C-0B83-4E74-69928E4423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2144" y="3208717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0035E98-5781-958D-D8DC-1D4652144E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2144" y="2724529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7DEC2C3C-3F7F-2817-7664-A96BF15FD0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2144" y="2240342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7D9BBE4-9016-F123-A58E-4A8906B697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2144" y="1756154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B0956E0-137A-B209-3405-E911F47718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2144" y="1273554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Freeform 33">
            <a:extLst>
              <a:ext uri="{FF2B5EF4-FFF2-40B4-BE49-F238E27FC236}">
                <a16:creationId xmlns:a16="http://schemas.microsoft.com/office/drawing/2014/main" id="{CB03A853-6C32-2C39-0763-80139B08C5D6}"/>
              </a:ext>
            </a:extLst>
          </p:cNvPr>
          <p:cNvSpPr>
            <a:spLocks/>
          </p:cNvSpPr>
          <p:nvPr/>
        </p:nvSpPr>
        <p:spPr bwMode="auto">
          <a:xfrm>
            <a:off x="3861353" y="1259368"/>
            <a:ext cx="3001963" cy="2619375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111FA7C4-67ED-D942-6003-869BC1D101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95859" y="3595603"/>
            <a:ext cx="56746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0" lang="ja-JP" altLang="ja-JP" sz="14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85C630A0-07E2-DA1B-C58C-CDB358AB005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615330" y="2461333"/>
            <a:ext cx="10643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cal control </a:t>
            </a:r>
            <a:endParaRPr kumimoji="0" lang="ja-JP" altLang="ja-JP" sz="14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Freeform 36">
            <a:extLst>
              <a:ext uri="{FF2B5EF4-FFF2-40B4-BE49-F238E27FC236}">
                <a16:creationId xmlns:a16="http://schemas.microsoft.com/office/drawing/2014/main" id="{B056116C-8DEC-0A68-FA1F-147DA1F75695}"/>
              </a:ext>
            </a:extLst>
          </p:cNvPr>
          <p:cNvSpPr>
            <a:spLocks/>
          </p:cNvSpPr>
          <p:nvPr/>
        </p:nvSpPr>
        <p:spPr bwMode="auto">
          <a:xfrm>
            <a:off x="3972478" y="1359381"/>
            <a:ext cx="2600325" cy="1544638"/>
          </a:xfrm>
          <a:custGeom>
            <a:avLst/>
            <a:gdLst>
              <a:gd name="T0" fmla="*/ 0 w 446"/>
              <a:gd name="T1" fmla="*/ 0 h 265"/>
              <a:gd name="T2" fmla="*/ 39 w 446"/>
              <a:gd name="T3" fmla="*/ 0 h 265"/>
              <a:gd name="T4" fmla="*/ 39 w 446"/>
              <a:gd name="T5" fmla="*/ 7 h 265"/>
              <a:gd name="T6" fmla="*/ 47 w 446"/>
              <a:gd name="T7" fmla="*/ 7 h 265"/>
              <a:gd name="T8" fmla="*/ 47 w 446"/>
              <a:gd name="T9" fmla="*/ 14 h 265"/>
              <a:gd name="T10" fmla="*/ 86 w 446"/>
              <a:gd name="T11" fmla="*/ 14 h 265"/>
              <a:gd name="T12" fmla="*/ 86 w 446"/>
              <a:gd name="T13" fmla="*/ 22 h 265"/>
              <a:gd name="T14" fmla="*/ 109 w 446"/>
              <a:gd name="T15" fmla="*/ 22 h 265"/>
              <a:gd name="T16" fmla="*/ 109 w 446"/>
              <a:gd name="T17" fmla="*/ 33 h 265"/>
              <a:gd name="T18" fmla="*/ 117 w 446"/>
              <a:gd name="T19" fmla="*/ 33 h 265"/>
              <a:gd name="T20" fmla="*/ 117 w 446"/>
              <a:gd name="T21" fmla="*/ 43 h 265"/>
              <a:gd name="T22" fmla="*/ 125 w 446"/>
              <a:gd name="T23" fmla="*/ 43 h 265"/>
              <a:gd name="T24" fmla="*/ 125 w 446"/>
              <a:gd name="T25" fmla="*/ 55 h 265"/>
              <a:gd name="T26" fmla="*/ 180 w 446"/>
              <a:gd name="T27" fmla="*/ 55 h 265"/>
              <a:gd name="T28" fmla="*/ 180 w 446"/>
              <a:gd name="T29" fmla="*/ 71 h 265"/>
              <a:gd name="T30" fmla="*/ 258 w 446"/>
              <a:gd name="T31" fmla="*/ 71 h 265"/>
              <a:gd name="T32" fmla="*/ 258 w 446"/>
              <a:gd name="T33" fmla="*/ 114 h 265"/>
              <a:gd name="T34" fmla="*/ 438 w 446"/>
              <a:gd name="T35" fmla="*/ 114 h 265"/>
              <a:gd name="T36" fmla="*/ 438 w 446"/>
              <a:gd name="T37" fmla="*/ 265 h 265"/>
              <a:gd name="T38" fmla="*/ 446 w 446"/>
              <a:gd name="T39" fmla="*/ 265 h 2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446" h="265">
                <a:moveTo>
                  <a:pt x="0" y="0"/>
                </a:moveTo>
                <a:lnTo>
                  <a:pt x="39" y="0"/>
                </a:lnTo>
                <a:lnTo>
                  <a:pt x="39" y="7"/>
                </a:lnTo>
                <a:lnTo>
                  <a:pt x="47" y="7"/>
                </a:lnTo>
                <a:lnTo>
                  <a:pt x="47" y="14"/>
                </a:lnTo>
                <a:lnTo>
                  <a:pt x="86" y="14"/>
                </a:lnTo>
                <a:lnTo>
                  <a:pt x="86" y="22"/>
                </a:lnTo>
                <a:lnTo>
                  <a:pt x="109" y="22"/>
                </a:lnTo>
                <a:lnTo>
                  <a:pt x="109" y="33"/>
                </a:lnTo>
                <a:lnTo>
                  <a:pt x="117" y="33"/>
                </a:lnTo>
                <a:lnTo>
                  <a:pt x="117" y="43"/>
                </a:lnTo>
                <a:lnTo>
                  <a:pt x="125" y="43"/>
                </a:lnTo>
                <a:lnTo>
                  <a:pt x="125" y="55"/>
                </a:lnTo>
                <a:lnTo>
                  <a:pt x="180" y="55"/>
                </a:lnTo>
                <a:lnTo>
                  <a:pt x="180" y="71"/>
                </a:lnTo>
                <a:lnTo>
                  <a:pt x="258" y="71"/>
                </a:lnTo>
                <a:lnTo>
                  <a:pt x="258" y="114"/>
                </a:lnTo>
                <a:lnTo>
                  <a:pt x="438" y="114"/>
                </a:lnTo>
                <a:lnTo>
                  <a:pt x="438" y="265"/>
                </a:lnTo>
                <a:lnTo>
                  <a:pt x="446" y="265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Freeform 37">
            <a:extLst>
              <a:ext uri="{FF2B5EF4-FFF2-40B4-BE49-F238E27FC236}">
                <a16:creationId xmlns:a16="http://schemas.microsoft.com/office/drawing/2014/main" id="{6E77A727-CCF2-A46F-1A57-68D546E63192}"/>
              </a:ext>
            </a:extLst>
          </p:cNvPr>
          <p:cNvSpPr>
            <a:spLocks/>
          </p:cNvSpPr>
          <p:nvPr/>
        </p:nvSpPr>
        <p:spPr bwMode="auto">
          <a:xfrm>
            <a:off x="3972478" y="1359381"/>
            <a:ext cx="2781300" cy="1836738"/>
          </a:xfrm>
          <a:custGeom>
            <a:avLst/>
            <a:gdLst>
              <a:gd name="T0" fmla="*/ 0 w 477"/>
              <a:gd name="T1" fmla="*/ 0 h 315"/>
              <a:gd name="T2" fmla="*/ 8 w 477"/>
              <a:gd name="T3" fmla="*/ 0 h 315"/>
              <a:gd name="T4" fmla="*/ 8 w 477"/>
              <a:gd name="T5" fmla="*/ 5 h 315"/>
              <a:gd name="T6" fmla="*/ 23 w 477"/>
              <a:gd name="T7" fmla="*/ 5 h 315"/>
              <a:gd name="T8" fmla="*/ 23 w 477"/>
              <a:gd name="T9" fmla="*/ 10 h 315"/>
              <a:gd name="T10" fmla="*/ 47 w 477"/>
              <a:gd name="T11" fmla="*/ 10 h 315"/>
              <a:gd name="T12" fmla="*/ 47 w 477"/>
              <a:gd name="T13" fmla="*/ 30 h 315"/>
              <a:gd name="T14" fmla="*/ 54 w 477"/>
              <a:gd name="T15" fmla="*/ 30 h 315"/>
              <a:gd name="T16" fmla="*/ 54 w 477"/>
              <a:gd name="T17" fmla="*/ 37 h 315"/>
              <a:gd name="T18" fmla="*/ 62 w 477"/>
              <a:gd name="T19" fmla="*/ 37 h 315"/>
              <a:gd name="T20" fmla="*/ 62 w 477"/>
              <a:gd name="T21" fmla="*/ 45 h 315"/>
              <a:gd name="T22" fmla="*/ 70 w 477"/>
              <a:gd name="T23" fmla="*/ 45 h 315"/>
              <a:gd name="T24" fmla="*/ 70 w 477"/>
              <a:gd name="T25" fmla="*/ 52 h 315"/>
              <a:gd name="T26" fmla="*/ 86 w 477"/>
              <a:gd name="T27" fmla="*/ 52 h 315"/>
              <a:gd name="T28" fmla="*/ 86 w 477"/>
              <a:gd name="T29" fmla="*/ 62 h 315"/>
              <a:gd name="T30" fmla="*/ 101 w 477"/>
              <a:gd name="T31" fmla="*/ 62 h 315"/>
              <a:gd name="T32" fmla="*/ 101 w 477"/>
              <a:gd name="T33" fmla="*/ 73 h 315"/>
              <a:gd name="T34" fmla="*/ 117 w 477"/>
              <a:gd name="T35" fmla="*/ 73 h 315"/>
              <a:gd name="T36" fmla="*/ 117 w 477"/>
              <a:gd name="T37" fmla="*/ 86 h 315"/>
              <a:gd name="T38" fmla="*/ 164 w 477"/>
              <a:gd name="T39" fmla="*/ 86 h 315"/>
              <a:gd name="T40" fmla="*/ 164 w 477"/>
              <a:gd name="T41" fmla="*/ 108 h 315"/>
              <a:gd name="T42" fmla="*/ 219 w 477"/>
              <a:gd name="T43" fmla="*/ 108 h 315"/>
              <a:gd name="T44" fmla="*/ 219 w 477"/>
              <a:gd name="T45" fmla="*/ 142 h 315"/>
              <a:gd name="T46" fmla="*/ 227 w 477"/>
              <a:gd name="T47" fmla="*/ 142 h 315"/>
              <a:gd name="T48" fmla="*/ 227 w 477"/>
              <a:gd name="T49" fmla="*/ 176 h 315"/>
              <a:gd name="T50" fmla="*/ 250 w 477"/>
              <a:gd name="T51" fmla="*/ 176 h 315"/>
              <a:gd name="T52" fmla="*/ 250 w 477"/>
              <a:gd name="T53" fmla="*/ 216 h 315"/>
              <a:gd name="T54" fmla="*/ 352 w 477"/>
              <a:gd name="T55" fmla="*/ 216 h 315"/>
              <a:gd name="T56" fmla="*/ 352 w 477"/>
              <a:gd name="T57" fmla="*/ 315 h 315"/>
              <a:gd name="T58" fmla="*/ 477 w 477"/>
              <a:gd name="T59" fmla="*/ 315 h 3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477" h="315">
                <a:moveTo>
                  <a:pt x="0" y="0"/>
                </a:moveTo>
                <a:lnTo>
                  <a:pt x="8" y="0"/>
                </a:lnTo>
                <a:lnTo>
                  <a:pt x="8" y="5"/>
                </a:lnTo>
                <a:lnTo>
                  <a:pt x="23" y="5"/>
                </a:lnTo>
                <a:lnTo>
                  <a:pt x="23" y="10"/>
                </a:lnTo>
                <a:lnTo>
                  <a:pt x="47" y="10"/>
                </a:lnTo>
                <a:lnTo>
                  <a:pt x="47" y="30"/>
                </a:lnTo>
                <a:lnTo>
                  <a:pt x="54" y="30"/>
                </a:lnTo>
                <a:lnTo>
                  <a:pt x="54" y="37"/>
                </a:lnTo>
                <a:lnTo>
                  <a:pt x="62" y="37"/>
                </a:lnTo>
                <a:lnTo>
                  <a:pt x="62" y="45"/>
                </a:lnTo>
                <a:lnTo>
                  <a:pt x="70" y="45"/>
                </a:lnTo>
                <a:lnTo>
                  <a:pt x="70" y="52"/>
                </a:lnTo>
                <a:lnTo>
                  <a:pt x="86" y="52"/>
                </a:lnTo>
                <a:lnTo>
                  <a:pt x="86" y="62"/>
                </a:lnTo>
                <a:lnTo>
                  <a:pt x="101" y="62"/>
                </a:lnTo>
                <a:lnTo>
                  <a:pt x="101" y="73"/>
                </a:lnTo>
                <a:lnTo>
                  <a:pt x="117" y="73"/>
                </a:lnTo>
                <a:lnTo>
                  <a:pt x="117" y="86"/>
                </a:lnTo>
                <a:lnTo>
                  <a:pt x="164" y="86"/>
                </a:lnTo>
                <a:lnTo>
                  <a:pt x="164" y="108"/>
                </a:lnTo>
                <a:lnTo>
                  <a:pt x="219" y="108"/>
                </a:lnTo>
                <a:lnTo>
                  <a:pt x="219" y="142"/>
                </a:lnTo>
                <a:lnTo>
                  <a:pt x="227" y="142"/>
                </a:lnTo>
                <a:lnTo>
                  <a:pt x="227" y="176"/>
                </a:lnTo>
                <a:lnTo>
                  <a:pt x="250" y="176"/>
                </a:lnTo>
                <a:lnTo>
                  <a:pt x="250" y="216"/>
                </a:lnTo>
                <a:lnTo>
                  <a:pt x="352" y="216"/>
                </a:lnTo>
                <a:lnTo>
                  <a:pt x="352" y="315"/>
                </a:lnTo>
                <a:lnTo>
                  <a:pt x="477" y="315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3C9F24D8-957E-DE48-6A39-7CA05BF6FF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97866" y="4269886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C3068EC8-63AE-1576-23F0-F282E757BC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1891" y="4269886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AC13F879-5416-16CC-DAA5-749B6E06E7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7503" y="4269886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F08873F5-E1E0-82D3-A695-AAD00E3BFB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1528" y="4269886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4BC0C1A-6FF4-3899-8D93-CE2965C49E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50478" y="4269886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3CD8E4CF-1FA0-7B30-CE40-A4D7727BA2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06091" y="4269886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70E65C19-152B-70F3-A2D6-604E35EEC1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0116" y="4269886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EB6AE177-D2EE-E22F-A605-D201AAF871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97866" y="4561368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3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D202F9A6-22A4-1EC1-E966-88DAC46DA6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1891" y="4561368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3924A105-95B5-B957-220A-820FF7D16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7503" y="4561368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07A90530-2D09-1B29-CA8B-1C6C6ACEE3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90103" y="4561368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96D267CD-43EF-4A66-45D3-8486D53E95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50478" y="4561368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E1A9BEE-E7EF-5315-B2AE-4AF6A971B7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06091" y="4561368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1B38A604-A553-F3C5-1057-42FF68174B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60116" y="4561368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400" b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Line 55">
            <a:extLst>
              <a:ext uri="{FF2B5EF4-FFF2-40B4-BE49-F238E27FC236}">
                <a16:creationId xmlns:a16="http://schemas.microsoft.com/office/drawing/2014/main" id="{306F18D5-724A-108F-5D4D-87B3A4B9F7C7}"/>
              </a:ext>
            </a:extLst>
          </p:cNvPr>
          <p:cNvSpPr>
            <a:spLocks noChangeShapeType="1"/>
          </p:cNvSpPr>
          <p:nvPr/>
        </p:nvSpPr>
        <p:spPr bwMode="auto">
          <a:xfrm>
            <a:off x="5721173" y="1264997"/>
            <a:ext cx="168275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Line 56">
            <a:extLst>
              <a:ext uri="{FF2B5EF4-FFF2-40B4-BE49-F238E27FC236}">
                <a16:creationId xmlns:a16="http://schemas.microsoft.com/office/drawing/2014/main" id="{F68CBF14-5076-485B-0827-A490DC37421B}"/>
              </a:ext>
            </a:extLst>
          </p:cNvPr>
          <p:cNvSpPr>
            <a:spLocks noChangeShapeType="1"/>
          </p:cNvSpPr>
          <p:nvPr/>
        </p:nvSpPr>
        <p:spPr bwMode="auto">
          <a:xfrm>
            <a:off x="5734188" y="1570336"/>
            <a:ext cx="168275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FF215B8A-4B36-9E55-0D87-75C7F1CC6E6B}"/>
              </a:ext>
            </a:extLst>
          </p:cNvPr>
          <p:cNvSpPr txBox="1"/>
          <p:nvPr/>
        </p:nvSpPr>
        <p:spPr>
          <a:xfrm>
            <a:off x="356951" y="148777"/>
            <a:ext cx="42129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(A). 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 according to CTV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E56A9C9-74A1-9720-F53B-CFD29D9AFBAF}"/>
              </a:ext>
            </a:extLst>
          </p:cNvPr>
          <p:cNvSpPr txBox="1"/>
          <p:nvPr/>
        </p:nvSpPr>
        <p:spPr>
          <a:xfrm>
            <a:off x="4355207" y="3190362"/>
            <a:ext cx="151592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494</a:t>
            </a:r>
          </a:p>
        </p:txBody>
      </p:sp>
      <p:sp>
        <p:nvSpPr>
          <p:cNvPr id="65" name="Rectangle 57">
            <a:extLst>
              <a:ext uri="{FF2B5EF4-FFF2-40B4-BE49-F238E27FC236}">
                <a16:creationId xmlns:a16="http://schemas.microsoft.com/office/drawing/2014/main" id="{2587768F-6F73-9532-7000-B139371EFF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1834" y="1460656"/>
            <a:ext cx="97077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m</a:t>
            </a:r>
            <a:r>
              <a:rPr kumimoji="0" lang="en-US" altLang="ja-JP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≤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57">
            <a:extLst>
              <a:ext uri="{FF2B5EF4-FFF2-40B4-BE49-F238E27FC236}">
                <a16:creationId xmlns:a16="http://schemas.microsoft.com/office/drawing/2014/main" id="{F80FA5B8-C6C5-EC3F-56A7-BF67E6A966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1834" y="1151645"/>
            <a:ext cx="10174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m</a:t>
            </a:r>
            <a:r>
              <a:rPr kumimoji="0" lang="en-US" altLang="ja-JP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Rectangle 57">
            <a:extLst>
              <a:ext uri="{FF2B5EF4-FFF2-40B4-BE49-F238E27FC236}">
                <a16:creationId xmlns:a16="http://schemas.microsoft.com/office/drawing/2014/main" id="{189C4628-0CBC-6FD9-EC9D-3C231C1AA3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9141" y="4555455"/>
            <a:ext cx="97077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m</a:t>
            </a:r>
            <a:r>
              <a:rPr kumimoji="0" lang="en-US" altLang="ja-JP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≤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Rectangle 57">
            <a:extLst>
              <a:ext uri="{FF2B5EF4-FFF2-40B4-BE49-F238E27FC236}">
                <a16:creationId xmlns:a16="http://schemas.microsoft.com/office/drawing/2014/main" id="{AAAFFFD6-CA8A-D8F0-9EBB-213CCF40E5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98749" y="4281340"/>
            <a:ext cx="101746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m</a:t>
            </a:r>
            <a:r>
              <a:rPr kumimoji="0" lang="en-US" altLang="ja-JP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A4ADBF3F-D172-BC9B-FE93-B13449991BE9}"/>
              </a:ext>
            </a:extLst>
          </p:cNvPr>
          <p:cNvSpPr txBox="1"/>
          <p:nvPr/>
        </p:nvSpPr>
        <p:spPr>
          <a:xfrm>
            <a:off x="3021204" y="861746"/>
            <a:ext cx="12781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ja-JP" sz="1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dirty="0"/>
          </a:p>
        </p:txBody>
      </p:sp>
      <p:sp>
        <p:nvSpPr>
          <p:cNvPr id="2" name="Rectangle 54">
            <a:extLst>
              <a:ext uri="{FF2B5EF4-FFF2-40B4-BE49-F238E27FC236}">
                <a16:creationId xmlns:a16="http://schemas.microsoft.com/office/drawing/2014/main" id="{74088158-6939-A24A-5716-5CE565D5D8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7384" y="4003493"/>
            <a:ext cx="7645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t risk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9412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EB207E35-3E77-0125-4364-B23E74D9AD9B}"/>
              </a:ext>
            </a:extLst>
          </p:cNvPr>
          <p:cNvSpPr txBox="1"/>
          <p:nvPr/>
        </p:nvSpPr>
        <p:spPr>
          <a:xfrm>
            <a:off x="599737" y="135597"/>
            <a:ext cx="41680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(B).  LC according to EQD2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B10E5E9C-78EB-2F6A-7DBC-445E89DDB133}"/>
              </a:ext>
            </a:extLst>
          </p:cNvPr>
          <p:cNvSpPr txBox="1"/>
          <p:nvPr/>
        </p:nvSpPr>
        <p:spPr>
          <a:xfrm>
            <a:off x="4396971" y="3365741"/>
            <a:ext cx="9701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313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Line 169">
            <a:extLst>
              <a:ext uri="{FF2B5EF4-FFF2-40B4-BE49-F238E27FC236}">
                <a16:creationId xmlns:a16="http://schemas.microsoft.com/office/drawing/2014/main" id="{4503A806-EBEB-8E02-2DAA-177BFFE61C0C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3814" y="4134607"/>
            <a:ext cx="2733675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Line 170">
            <a:extLst>
              <a:ext uri="{FF2B5EF4-FFF2-40B4-BE49-F238E27FC236}">
                <a16:creationId xmlns:a16="http://schemas.microsoft.com/office/drawing/2014/main" id="{179371E8-A092-352B-2DEC-BAB1832494FC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8008" y="413460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Line 171">
            <a:extLst>
              <a:ext uri="{FF2B5EF4-FFF2-40B4-BE49-F238E27FC236}">
                <a16:creationId xmlns:a16="http://schemas.microsoft.com/office/drawing/2014/main" id="{7675C516-550E-2AFC-5CE7-363634DF9707}"/>
              </a:ext>
            </a:extLst>
          </p:cNvPr>
          <p:cNvSpPr>
            <a:spLocks noChangeShapeType="1"/>
          </p:cNvSpPr>
          <p:nvPr/>
        </p:nvSpPr>
        <p:spPr bwMode="auto">
          <a:xfrm>
            <a:off x="4627839" y="413460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Line 172">
            <a:extLst>
              <a:ext uri="{FF2B5EF4-FFF2-40B4-BE49-F238E27FC236}">
                <a16:creationId xmlns:a16="http://schemas.microsoft.com/office/drawing/2014/main" id="{8DD712CB-5CCF-2A5D-B9D2-A63914B1179C}"/>
              </a:ext>
            </a:extLst>
          </p:cNvPr>
          <p:cNvSpPr>
            <a:spLocks noChangeShapeType="1"/>
          </p:cNvSpPr>
          <p:nvPr/>
        </p:nvSpPr>
        <p:spPr bwMode="auto">
          <a:xfrm>
            <a:off x="5083452" y="413460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Line 173">
            <a:extLst>
              <a:ext uri="{FF2B5EF4-FFF2-40B4-BE49-F238E27FC236}">
                <a16:creationId xmlns:a16="http://schemas.microsoft.com/office/drawing/2014/main" id="{7B2BEE6B-CCFC-BFB6-2E34-D93D11BC6E74}"/>
              </a:ext>
            </a:extLst>
          </p:cNvPr>
          <p:cNvSpPr>
            <a:spLocks noChangeShapeType="1"/>
          </p:cNvSpPr>
          <p:nvPr/>
        </p:nvSpPr>
        <p:spPr bwMode="auto">
          <a:xfrm>
            <a:off x="5537477" y="413460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Line 174">
            <a:extLst>
              <a:ext uri="{FF2B5EF4-FFF2-40B4-BE49-F238E27FC236}">
                <a16:creationId xmlns:a16="http://schemas.microsoft.com/office/drawing/2014/main" id="{A4B317FF-7349-6732-E611-C4F63C9A19F5}"/>
              </a:ext>
            </a:extLst>
          </p:cNvPr>
          <p:cNvSpPr>
            <a:spLocks noChangeShapeType="1"/>
          </p:cNvSpPr>
          <p:nvPr/>
        </p:nvSpPr>
        <p:spPr bwMode="auto">
          <a:xfrm>
            <a:off x="5997852" y="413460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Line 175">
            <a:extLst>
              <a:ext uri="{FF2B5EF4-FFF2-40B4-BE49-F238E27FC236}">
                <a16:creationId xmlns:a16="http://schemas.microsoft.com/office/drawing/2014/main" id="{DF67B5E1-6DB8-9D97-2A7C-C5AB9F1EC528}"/>
              </a:ext>
            </a:extLst>
          </p:cNvPr>
          <p:cNvSpPr>
            <a:spLocks noChangeShapeType="1"/>
          </p:cNvSpPr>
          <p:nvPr/>
        </p:nvSpPr>
        <p:spPr bwMode="auto">
          <a:xfrm>
            <a:off x="6453464" y="413460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Line 176">
            <a:extLst>
              <a:ext uri="{FF2B5EF4-FFF2-40B4-BE49-F238E27FC236}">
                <a16:creationId xmlns:a16="http://schemas.microsoft.com/office/drawing/2014/main" id="{80C54E3A-582D-9627-DB2B-F7657F731E29}"/>
              </a:ext>
            </a:extLst>
          </p:cNvPr>
          <p:cNvSpPr>
            <a:spLocks noChangeShapeType="1"/>
          </p:cNvSpPr>
          <p:nvPr/>
        </p:nvSpPr>
        <p:spPr bwMode="auto">
          <a:xfrm>
            <a:off x="6907489" y="4134607"/>
            <a:ext cx="0" cy="52388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Rectangle 177">
            <a:extLst>
              <a:ext uri="{FF2B5EF4-FFF2-40B4-BE49-F238E27FC236}">
                <a16:creationId xmlns:a16="http://schemas.microsoft.com/office/drawing/2014/main" id="{403DF5ED-5E8D-DECF-C4A2-C277D8F9E6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1971" y="4256845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Rectangle 178">
            <a:extLst>
              <a:ext uri="{FF2B5EF4-FFF2-40B4-BE49-F238E27FC236}">
                <a16:creationId xmlns:a16="http://schemas.microsoft.com/office/drawing/2014/main" id="{C3C6324E-331B-3CB5-B2E3-005842FB3A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3227" y="4256845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Rectangle 179">
            <a:extLst>
              <a:ext uri="{FF2B5EF4-FFF2-40B4-BE49-F238E27FC236}">
                <a16:creationId xmlns:a16="http://schemas.microsoft.com/office/drawing/2014/main" id="{39EBC105-2805-360E-DD08-30694BE9C8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8839" y="4256845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Rectangle 180">
            <a:extLst>
              <a:ext uri="{FF2B5EF4-FFF2-40B4-BE49-F238E27FC236}">
                <a16:creationId xmlns:a16="http://schemas.microsoft.com/office/drawing/2014/main" id="{3B89F7EF-9A7B-D5EE-6C74-B6BD18583E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62864" y="4256845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Rectangle 181">
            <a:extLst>
              <a:ext uri="{FF2B5EF4-FFF2-40B4-BE49-F238E27FC236}">
                <a16:creationId xmlns:a16="http://schemas.microsoft.com/office/drawing/2014/main" id="{7D94220D-90FE-68DC-9189-400475CC71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23239" y="4256845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Rectangle 182">
            <a:extLst>
              <a:ext uri="{FF2B5EF4-FFF2-40B4-BE49-F238E27FC236}">
                <a16:creationId xmlns:a16="http://schemas.microsoft.com/office/drawing/2014/main" id="{8A432D73-E588-80EC-D292-85EF91CFD9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8852" y="4256845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Rectangle 183">
            <a:extLst>
              <a:ext uri="{FF2B5EF4-FFF2-40B4-BE49-F238E27FC236}">
                <a16:creationId xmlns:a16="http://schemas.microsoft.com/office/drawing/2014/main" id="{296D6BBD-7CD6-87CC-A645-969F29EC48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32877" y="4256845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Line 184">
            <a:extLst>
              <a:ext uri="{FF2B5EF4-FFF2-40B4-BE49-F238E27FC236}">
                <a16:creationId xmlns:a16="http://schemas.microsoft.com/office/drawing/2014/main" id="{45FBD9F5-A5B5-B2CB-BCF5-8F3DE0F1A56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062689" y="1615245"/>
            <a:ext cx="0" cy="241935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Line 185">
            <a:extLst>
              <a:ext uri="{FF2B5EF4-FFF2-40B4-BE49-F238E27FC236}">
                <a16:creationId xmlns:a16="http://schemas.microsoft.com/office/drawing/2014/main" id="{69969E16-D9CA-191D-AC61-135585891FC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08146" y="4034595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Line 186">
            <a:extLst>
              <a:ext uri="{FF2B5EF4-FFF2-40B4-BE49-F238E27FC236}">
                <a16:creationId xmlns:a16="http://schemas.microsoft.com/office/drawing/2014/main" id="{03718173-4E49-D1AF-C900-43A66E17086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03952" y="3550407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Line 187">
            <a:extLst>
              <a:ext uri="{FF2B5EF4-FFF2-40B4-BE49-F238E27FC236}">
                <a16:creationId xmlns:a16="http://schemas.microsoft.com/office/drawing/2014/main" id="{7BFB0EDF-078F-4DA8-7F36-8C32AAB5ABE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03952" y="3066220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Line 188">
            <a:extLst>
              <a:ext uri="{FF2B5EF4-FFF2-40B4-BE49-F238E27FC236}">
                <a16:creationId xmlns:a16="http://schemas.microsoft.com/office/drawing/2014/main" id="{596D0A4E-3E28-63E3-55A4-04A49B6744C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03952" y="2583620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Line 189">
            <a:extLst>
              <a:ext uri="{FF2B5EF4-FFF2-40B4-BE49-F238E27FC236}">
                <a16:creationId xmlns:a16="http://schemas.microsoft.com/office/drawing/2014/main" id="{6AED67DB-653D-C681-46DF-4102CA1F7F2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03952" y="2099432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Line 190">
            <a:extLst>
              <a:ext uri="{FF2B5EF4-FFF2-40B4-BE49-F238E27FC236}">
                <a16:creationId xmlns:a16="http://schemas.microsoft.com/office/drawing/2014/main" id="{799796E9-31AE-32B7-19C6-857B00C3B11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03952" y="1615245"/>
            <a:ext cx="58738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Rectangle 191">
            <a:extLst>
              <a:ext uri="{FF2B5EF4-FFF2-40B4-BE49-F238E27FC236}">
                <a16:creationId xmlns:a16="http://schemas.microsoft.com/office/drawing/2014/main" id="{E1635145-4E98-8427-082B-2D0B16920F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6065" y="3931991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Rectangle 192">
            <a:extLst>
              <a:ext uri="{FF2B5EF4-FFF2-40B4-BE49-F238E27FC236}">
                <a16:creationId xmlns:a16="http://schemas.microsoft.com/office/drawing/2014/main" id="{AEE8B474-686B-003B-F2DB-D302268282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6065" y="3447804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Rectangle 193">
            <a:extLst>
              <a:ext uri="{FF2B5EF4-FFF2-40B4-BE49-F238E27FC236}">
                <a16:creationId xmlns:a16="http://schemas.microsoft.com/office/drawing/2014/main" id="{FB1BE082-8928-BDE6-E736-42713FBA38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6065" y="2963616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Rectangle 194">
            <a:extLst>
              <a:ext uri="{FF2B5EF4-FFF2-40B4-BE49-F238E27FC236}">
                <a16:creationId xmlns:a16="http://schemas.microsoft.com/office/drawing/2014/main" id="{C57B14B6-89CA-6DA4-0997-120D1EA0DE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6065" y="2479429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Rectangle 195">
            <a:extLst>
              <a:ext uri="{FF2B5EF4-FFF2-40B4-BE49-F238E27FC236}">
                <a16:creationId xmlns:a16="http://schemas.microsoft.com/office/drawing/2014/main" id="{731F86C7-83A9-809D-A8DD-46F1CD405E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6065" y="1995241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Rectangle 196">
            <a:extLst>
              <a:ext uri="{FF2B5EF4-FFF2-40B4-BE49-F238E27FC236}">
                <a16:creationId xmlns:a16="http://schemas.microsoft.com/office/drawing/2014/main" id="{5DA2446D-957E-0E55-6FB8-7D441FB7EE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6065" y="1512641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Freeform 197">
            <a:extLst>
              <a:ext uri="{FF2B5EF4-FFF2-40B4-BE49-F238E27FC236}">
                <a16:creationId xmlns:a16="http://schemas.microsoft.com/office/drawing/2014/main" id="{1CCE5C1F-91A4-C5EB-4C7E-02DF3F73DD48}"/>
              </a:ext>
            </a:extLst>
          </p:cNvPr>
          <p:cNvSpPr>
            <a:spLocks/>
          </p:cNvSpPr>
          <p:nvPr/>
        </p:nvSpPr>
        <p:spPr bwMode="auto">
          <a:xfrm>
            <a:off x="4062689" y="1515232"/>
            <a:ext cx="3001963" cy="2619375"/>
          </a:xfrm>
          <a:custGeom>
            <a:avLst/>
            <a:gdLst>
              <a:gd name="T0" fmla="*/ 0 w 515"/>
              <a:gd name="T1" fmla="*/ 0 h 449"/>
              <a:gd name="T2" fmla="*/ 0 w 515"/>
              <a:gd name="T3" fmla="*/ 449 h 449"/>
              <a:gd name="T4" fmla="*/ 515 w 515"/>
              <a:gd name="T5" fmla="*/ 449 h 4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49">
                <a:moveTo>
                  <a:pt x="0" y="0"/>
                </a:moveTo>
                <a:lnTo>
                  <a:pt x="0" y="449"/>
                </a:lnTo>
                <a:lnTo>
                  <a:pt x="515" y="449"/>
                </a:lnTo>
              </a:path>
            </a:pathLst>
          </a:cu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Rectangle 198">
            <a:extLst>
              <a:ext uri="{FF2B5EF4-FFF2-40B4-BE49-F238E27FC236}">
                <a16:creationId xmlns:a16="http://schemas.microsoft.com/office/drawing/2014/main" id="{7C39D252-47CC-8C5C-6D5E-40F2AD305D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03183" y="3796925"/>
            <a:ext cx="56746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Freeform 200">
            <a:extLst>
              <a:ext uri="{FF2B5EF4-FFF2-40B4-BE49-F238E27FC236}">
                <a16:creationId xmlns:a16="http://schemas.microsoft.com/office/drawing/2014/main" id="{4A28C046-299F-1E1B-289A-759197D86B84}"/>
              </a:ext>
            </a:extLst>
          </p:cNvPr>
          <p:cNvSpPr>
            <a:spLocks/>
          </p:cNvSpPr>
          <p:nvPr/>
        </p:nvSpPr>
        <p:spPr bwMode="auto">
          <a:xfrm>
            <a:off x="4173814" y="1615245"/>
            <a:ext cx="2552700" cy="2419350"/>
          </a:xfrm>
          <a:custGeom>
            <a:avLst/>
            <a:gdLst>
              <a:gd name="T0" fmla="*/ 0 w 438"/>
              <a:gd name="T1" fmla="*/ 0 h 415"/>
              <a:gd name="T2" fmla="*/ 23 w 438"/>
              <a:gd name="T3" fmla="*/ 0 h 415"/>
              <a:gd name="T4" fmla="*/ 23 w 438"/>
              <a:gd name="T5" fmla="*/ 14 h 415"/>
              <a:gd name="T6" fmla="*/ 39 w 438"/>
              <a:gd name="T7" fmla="*/ 14 h 415"/>
              <a:gd name="T8" fmla="*/ 39 w 438"/>
              <a:gd name="T9" fmla="*/ 29 h 415"/>
              <a:gd name="T10" fmla="*/ 47 w 438"/>
              <a:gd name="T11" fmla="*/ 29 h 415"/>
              <a:gd name="T12" fmla="*/ 47 w 438"/>
              <a:gd name="T13" fmla="*/ 44 h 415"/>
              <a:gd name="T14" fmla="*/ 70 w 438"/>
              <a:gd name="T15" fmla="*/ 44 h 415"/>
              <a:gd name="T16" fmla="*/ 70 w 438"/>
              <a:gd name="T17" fmla="*/ 60 h 415"/>
              <a:gd name="T18" fmla="*/ 86 w 438"/>
              <a:gd name="T19" fmla="*/ 60 h 415"/>
              <a:gd name="T20" fmla="*/ 86 w 438"/>
              <a:gd name="T21" fmla="*/ 97 h 415"/>
              <a:gd name="T22" fmla="*/ 117 w 438"/>
              <a:gd name="T23" fmla="*/ 97 h 415"/>
              <a:gd name="T24" fmla="*/ 117 w 438"/>
              <a:gd name="T25" fmla="*/ 126 h 415"/>
              <a:gd name="T26" fmla="*/ 180 w 438"/>
              <a:gd name="T27" fmla="*/ 126 h 415"/>
              <a:gd name="T28" fmla="*/ 180 w 438"/>
              <a:gd name="T29" fmla="*/ 174 h 415"/>
              <a:gd name="T30" fmla="*/ 438 w 438"/>
              <a:gd name="T31" fmla="*/ 174 h 415"/>
              <a:gd name="T32" fmla="*/ 438 w 438"/>
              <a:gd name="T33" fmla="*/ 415 h 4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438" h="415">
                <a:moveTo>
                  <a:pt x="0" y="0"/>
                </a:moveTo>
                <a:lnTo>
                  <a:pt x="23" y="0"/>
                </a:lnTo>
                <a:lnTo>
                  <a:pt x="23" y="14"/>
                </a:lnTo>
                <a:lnTo>
                  <a:pt x="39" y="14"/>
                </a:lnTo>
                <a:lnTo>
                  <a:pt x="39" y="29"/>
                </a:lnTo>
                <a:lnTo>
                  <a:pt x="47" y="29"/>
                </a:lnTo>
                <a:lnTo>
                  <a:pt x="47" y="44"/>
                </a:lnTo>
                <a:lnTo>
                  <a:pt x="70" y="44"/>
                </a:lnTo>
                <a:lnTo>
                  <a:pt x="70" y="60"/>
                </a:lnTo>
                <a:lnTo>
                  <a:pt x="86" y="60"/>
                </a:lnTo>
                <a:lnTo>
                  <a:pt x="86" y="97"/>
                </a:lnTo>
                <a:lnTo>
                  <a:pt x="117" y="97"/>
                </a:lnTo>
                <a:lnTo>
                  <a:pt x="117" y="126"/>
                </a:lnTo>
                <a:lnTo>
                  <a:pt x="180" y="126"/>
                </a:lnTo>
                <a:lnTo>
                  <a:pt x="180" y="174"/>
                </a:lnTo>
                <a:lnTo>
                  <a:pt x="438" y="174"/>
                </a:lnTo>
                <a:lnTo>
                  <a:pt x="438" y="415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Freeform 201">
            <a:extLst>
              <a:ext uri="{FF2B5EF4-FFF2-40B4-BE49-F238E27FC236}">
                <a16:creationId xmlns:a16="http://schemas.microsoft.com/office/drawing/2014/main" id="{927D7728-DE53-5702-4C46-65A17F42AA5F}"/>
              </a:ext>
            </a:extLst>
          </p:cNvPr>
          <p:cNvSpPr>
            <a:spLocks/>
          </p:cNvSpPr>
          <p:nvPr/>
        </p:nvSpPr>
        <p:spPr bwMode="auto">
          <a:xfrm>
            <a:off x="4173814" y="1615245"/>
            <a:ext cx="2781300" cy="1258888"/>
          </a:xfrm>
          <a:custGeom>
            <a:avLst/>
            <a:gdLst>
              <a:gd name="T0" fmla="*/ 0 w 477"/>
              <a:gd name="T1" fmla="*/ 0 h 216"/>
              <a:gd name="T2" fmla="*/ 8 w 477"/>
              <a:gd name="T3" fmla="*/ 0 h 216"/>
              <a:gd name="T4" fmla="*/ 8 w 477"/>
              <a:gd name="T5" fmla="*/ 3 h 216"/>
              <a:gd name="T6" fmla="*/ 47 w 477"/>
              <a:gd name="T7" fmla="*/ 3 h 216"/>
              <a:gd name="T8" fmla="*/ 47 w 477"/>
              <a:gd name="T9" fmla="*/ 16 h 216"/>
              <a:gd name="T10" fmla="*/ 54 w 477"/>
              <a:gd name="T11" fmla="*/ 16 h 216"/>
              <a:gd name="T12" fmla="*/ 54 w 477"/>
              <a:gd name="T13" fmla="*/ 21 h 216"/>
              <a:gd name="T14" fmla="*/ 62 w 477"/>
              <a:gd name="T15" fmla="*/ 21 h 216"/>
              <a:gd name="T16" fmla="*/ 62 w 477"/>
              <a:gd name="T17" fmla="*/ 26 h 216"/>
              <a:gd name="T18" fmla="*/ 101 w 477"/>
              <a:gd name="T19" fmla="*/ 26 h 216"/>
              <a:gd name="T20" fmla="*/ 101 w 477"/>
              <a:gd name="T21" fmla="*/ 32 h 216"/>
              <a:gd name="T22" fmla="*/ 109 w 477"/>
              <a:gd name="T23" fmla="*/ 32 h 216"/>
              <a:gd name="T24" fmla="*/ 109 w 477"/>
              <a:gd name="T25" fmla="*/ 40 h 216"/>
              <a:gd name="T26" fmla="*/ 117 w 477"/>
              <a:gd name="T27" fmla="*/ 40 h 216"/>
              <a:gd name="T28" fmla="*/ 117 w 477"/>
              <a:gd name="T29" fmla="*/ 47 h 216"/>
              <a:gd name="T30" fmla="*/ 125 w 477"/>
              <a:gd name="T31" fmla="*/ 47 h 216"/>
              <a:gd name="T32" fmla="*/ 125 w 477"/>
              <a:gd name="T33" fmla="*/ 55 h 216"/>
              <a:gd name="T34" fmla="*/ 164 w 477"/>
              <a:gd name="T35" fmla="*/ 55 h 216"/>
              <a:gd name="T36" fmla="*/ 164 w 477"/>
              <a:gd name="T37" fmla="*/ 66 h 216"/>
              <a:gd name="T38" fmla="*/ 219 w 477"/>
              <a:gd name="T39" fmla="*/ 66 h 216"/>
              <a:gd name="T40" fmla="*/ 219 w 477"/>
              <a:gd name="T41" fmla="*/ 83 h 216"/>
              <a:gd name="T42" fmla="*/ 227 w 477"/>
              <a:gd name="T43" fmla="*/ 83 h 216"/>
              <a:gd name="T44" fmla="*/ 227 w 477"/>
              <a:gd name="T45" fmla="*/ 101 h 216"/>
              <a:gd name="T46" fmla="*/ 250 w 477"/>
              <a:gd name="T47" fmla="*/ 101 h 216"/>
              <a:gd name="T48" fmla="*/ 250 w 477"/>
              <a:gd name="T49" fmla="*/ 126 h 216"/>
              <a:gd name="T50" fmla="*/ 258 w 477"/>
              <a:gd name="T51" fmla="*/ 126 h 216"/>
              <a:gd name="T52" fmla="*/ 258 w 477"/>
              <a:gd name="T53" fmla="*/ 150 h 216"/>
              <a:gd name="T54" fmla="*/ 352 w 477"/>
              <a:gd name="T55" fmla="*/ 150 h 216"/>
              <a:gd name="T56" fmla="*/ 352 w 477"/>
              <a:gd name="T57" fmla="*/ 216 h 216"/>
              <a:gd name="T58" fmla="*/ 477 w 477"/>
              <a:gd name="T59" fmla="*/ 216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477" h="216">
                <a:moveTo>
                  <a:pt x="0" y="0"/>
                </a:moveTo>
                <a:lnTo>
                  <a:pt x="8" y="0"/>
                </a:lnTo>
                <a:lnTo>
                  <a:pt x="8" y="3"/>
                </a:lnTo>
                <a:lnTo>
                  <a:pt x="47" y="3"/>
                </a:lnTo>
                <a:lnTo>
                  <a:pt x="47" y="16"/>
                </a:lnTo>
                <a:lnTo>
                  <a:pt x="54" y="16"/>
                </a:lnTo>
                <a:lnTo>
                  <a:pt x="54" y="21"/>
                </a:lnTo>
                <a:lnTo>
                  <a:pt x="62" y="21"/>
                </a:lnTo>
                <a:lnTo>
                  <a:pt x="62" y="26"/>
                </a:lnTo>
                <a:lnTo>
                  <a:pt x="101" y="26"/>
                </a:lnTo>
                <a:lnTo>
                  <a:pt x="101" y="32"/>
                </a:lnTo>
                <a:lnTo>
                  <a:pt x="109" y="32"/>
                </a:lnTo>
                <a:lnTo>
                  <a:pt x="109" y="40"/>
                </a:lnTo>
                <a:lnTo>
                  <a:pt x="117" y="40"/>
                </a:lnTo>
                <a:lnTo>
                  <a:pt x="117" y="47"/>
                </a:lnTo>
                <a:lnTo>
                  <a:pt x="125" y="47"/>
                </a:lnTo>
                <a:lnTo>
                  <a:pt x="125" y="55"/>
                </a:lnTo>
                <a:lnTo>
                  <a:pt x="164" y="55"/>
                </a:lnTo>
                <a:lnTo>
                  <a:pt x="164" y="66"/>
                </a:lnTo>
                <a:lnTo>
                  <a:pt x="219" y="66"/>
                </a:lnTo>
                <a:lnTo>
                  <a:pt x="219" y="83"/>
                </a:lnTo>
                <a:lnTo>
                  <a:pt x="227" y="83"/>
                </a:lnTo>
                <a:lnTo>
                  <a:pt x="227" y="101"/>
                </a:lnTo>
                <a:lnTo>
                  <a:pt x="250" y="101"/>
                </a:lnTo>
                <a:lnTo>
                  <a:pt x="250" y="126"/>
                </a:lnTo>
                <a:lnTo>
                  <a:pt x="258" y="126"/>
                </a:lnTo>
                <a:lnTo>
                  <a:pt x="258" y="150"/>
                </a:lnTo>
                <a:lnTo>
                  <a:pt x="352" y="150"/>
                </a:lnTo>
                <a:lnTo>
                  <a:pt x="352" y="216"/>
                </a:lnTo>
                <a:lnTo>
                  <a:pt x="477" y="216"/>
                </a:lnTo>
              </a:path>
            </a:pathLst>
          </a:cu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Rectangle 202">
            <a:extLst>
              <a:ext uri="{FF2B5EF4-FFF2-40B4-BE49-F238E27FC236}">
                <a16:creationId xmlns:a16="http://schemas.microsoft.com/office/drawing/2014/main" id="{61A5B8B5-92FE-36DC-8641-A83EA55917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9202" y="4592859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Rectangle 203">
            <a:extLst>
              <a:ext uri="{FF2B5EF4-FFF2-40B4-BE49-F238E27FC236}">
                <a16:creationId xmlns:a16="http://schemas.microsoft.com/office/drawing/2014/main" id="{6A655E72-BB05-365E-DBA2-43197FB64E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3227" y="4592859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Rectangle 204">
            <a:extLst>
              <a:ext uri="{FF2B5EF4-FFF2-40B4-BE49-F238E27FC236}">
                <a16:creationId xmlns:a16="http://schemas.microsoft.com/office/drawing/2014/main" id="{2625EAED-54FE-0BE1-3A6A-85F42AF76D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37414" y="4592859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Rectangle 205">
            <a:extLst>
              <a:ext uri="{FF2B5EF4-FFF2-40B4-BE49-F238E27FC236}">
                <a16:creationId xmlns:a16="http://schemas.microsoft.com/office/drawing/2014/main" id="{CA804568-F157-690E-8A1F-2B4EE60EEF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1439" y="4592859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Rectangle 206">
            <a:extLst>
              <a:ext uri="{FF2B5EF4-FFF2-40B4-BE49-F238E27FC236}">
                <a16:creationId xmlns:a16="http://schemas.microsoft.com/office/drawing/2014/main" id="{6817066A-7335-F647-9C3C-08D68E3E94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1814" y="4592859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Rectangle 207">
            <a:extLst>
              <a:ext uri="{FF2B5EF4-FFF2-40B4-BE49-F238E27FC236}">
                <a16:creationId xmlns:a16="http://schemas.microsoft.com/office/drawing/2014/main" id="{5DDACCF4-9548-3514-00A1-FCF64A03EE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7427" y="4592859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Rectangle 208">
            <a:extLst>
              <a:ext uri="{FF2B5EF4-FFF2-40B4-BE49-F238E27FC236}">
                <a16:creationId xmlns:a16="http://schemas.microsoft.com/office/drawing/2014/main" id="{61EDC5EF-106E-D7FF-7089-B01F18FBA3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1452" y="4592859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Rectangle 209">
            <a:extLst>
              <a:ext uri="{FF2B5EF4-FFF2-40B4-BE49-F238E27FC236}">
                <a16:creationId xmlns:a16="http://schemas.microsoft.com/office/drawing/2014/main" id="{5F2E2671-B223-7CA6-CFEF-EF8DCC5E05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2214" y="4917894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Rectangle 210">
            <a:extLst>
              <a:ext uri="{FF2B5EF4-FFF2-40B4-BE49-F238E27FC236}">
                <a16:creationId xmlns:a16="http://schemas.microsoft.com/office/drawing/2014/main" id="{ABC60CCC-EF64-8AC2-0A56-08EC8B0576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3227" y="4917894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Rectangle 211">
            <a:extLst>
              <a:ext uri="{FF2B5EF4-FFF2-40B4-BE49-F238E27FC236}">
                <a16:creationId xmlns:a16="http://schemas.microsoft.com/office/drawing/2014/main" id="{F61059EB-0D23-FDA5-CC02-D4783DBE61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8839" y="4917894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Rectangle 212">
            <a:extLst>
              <a:ext uri="{FF2B5EF4-FFF2-40B4-BE49-F238E27FC236}">
                <a16:creationId xmlns:a16="http://schemas.microsoft.com/office/drawing/2014/main" id="{BCF58C7A-E598-4D9F-FFC9-A8306B06EC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62864" y="4917894"/>
            <a:ext cx="1795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Rectangle 213">
            <a:extLst>
              <a:ext uri="{FF2B5EF4-FFF2-40B4-BE49-F238E27FC236}">
                <a16:creationId xmlns:a16="http://schemas.microsoft.com/office/drawing/2014/main" id="{F852190C-DA3B-E37B-691D-DF8C8113ED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1814" y="4917894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Rectangle 214">
            <a:extLst>
              <a:ext uri="{FF2B5EF4-FFF2-40B4-BE49-F238E27FC236}">
                <a16:creationId xmlns:a16="http://schemas.microsoft.com/office/drawing/2014/main" id="{AE8626E8-A636-5A73-F07F-57AD10E75C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07427" y="4917894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Rectangle 215">
            <a:extLst>
              <a:ext uri="{FF2B5EF4-FFF2-40B4-BE49-F238E27FC236}">
                <a16:creationId xmlns:a16="http://schemas.microsoft.com/office/drawing/2014/main" id="{F8439593-B2A3-C263-CDFF-7380AA2D04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61452" y="4917894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ja-JP" altLang="ja-JP" sz="1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Line 114">
            <a:extLst>
              <a:ext uri="{FF2B5EF4-FFF2-40B4-BE49-F238E27FC236}">
                <a16:creationId xmlns:a16="http://schemas.microsoft.com/office/drawing/2014/main" id="{CEDB8780-1D0A-3BC2-54BB-A5740920CF8D}"/>
              </a:ext>
            </a:extLst>
          </p:cNvPr>
          <p:cNvSpPr>
            <a:spLocks noChangeShapeType="1"/>
          </p:cNvSpPr>
          <p:nvPr/>
        </p:nvSpPr>
        <p:spPr bwMode="auto">
          <a:xfrm>
            <a:off x="6005851" y="1721542"/>
            <a:ext cx="236538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Line 115">
            <a:extLst>
              <a:ext uri="{FF2B5EF4-FFF2-40B4-BE49-F238E27FC236}">
                <a16:creationId xmlns:a16="http://schemas.microsoft.com/office/drawing/2014/main" id="{4FF7FF68-328C-81D6-6D29-9B675E48FEA6}"/>
              </a:ext>
            </a:extLst>
          </p:cNvPr>
          <p:cNvSpPr>
            <a:spLocks noChangeShapeType="1"/>
          </p:cNvSpPr>
          <p:nvPr/>
        </p:nvSpPr>
        <p:spPr bwMode="auto">
          <a:xfrm>
            <a:off x="6005851" y="2067834"/>
            <a:ext cx="236538" cy="0"/>
          </a:xfrm>
          <a:prstGeom prst="line">
            <a:avLst/>
          </a:prstGeom>
          <a:noFill/>
          <a:ln w="28575" cap="rnd">
            <a:solidFill>
              <a:srgbClr val="DF536B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D001B9B-8DA5-9E26-8560-8F0DBE1EF4E5}"/>
              </a:ext>
            </a:extLst>
          </p:cNvPr>
          <p:cNvSpPr txBox="1"/>
          <p:nvPr/>
        </p:nvSpPr>
        <p:spPr>
          <a:xfrm>
            <a:off x="6320042" y="1902908"/>
            <a:ext cx="185509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QD2 </a:t>
            </a:r>
            <a:r>
              <a:rPr lang="ja-JP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≥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67 Gy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72BEF75A-09C8-96AE-D463-D658540F6D2A}"/>
              </a:ext>
            </a:extLst>
          </p:cNvPr>
          <p:cNvSpPr txBox="1"/>
          <p:nvPr/>
        </p:nvSpPr>
        <p:spPr>
          <a:xfrm>
            <a:off x="6292305" y="1558030"/>
            <a:ext cx="185509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QD2 </a:t>
            </a:r>
            <a:r>
              <a:rPr lang="en-US" altLang="ja-JP" sz="14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</a:t>
            </a:r>
            <a:r>
              <a:rPr lang="ja-JP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67 Gy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33496053-9254-B0D0-621D-BB1B53F0E5A7}"/>
              </a:ext>
            </a:extLst>
          </p:cNvPr>
          <p:cNvSpPr txBox="1"/>
          <p:nvPr/>
        </p:nvSpPr>
        <p:spPr>
          <a:xfrm>
            <a:off x="2667815" y="4880812"/>
            <a:ext cx="185509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QD2 </a:t>
            </a:r>
            <a:r>
              <a:rPr lang="ja-JP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≥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67 Gy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584F251A-6531-F99C-97D7-7B85690B2954}"/>
              </a:ext>
            </a:extLst>
          </p:cNvPr>
          <p:cNvSpPr txBox="1"/>
          <p:nvPr/>
        </p:nvSpPr>
        <p:spPr>
          <a:xfrm>
            <a:off x="2682577" y="4532609"/>
            <a:ext cx="185509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QD2 </a:t>
            </a:r>
            <a:r>
              <a:rPr lang="en-US" altLang="ja-JP" sz="14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</a:t>
            </a:r>
            <a:r>
              <a:rPr lang="ja-JP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67 Gy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35">
            <a:extLst>
              <a:ext uri="{FF2B5EF4-FFF2-40B4-BE49-F238E27FC236}">
                <a16:creationId xmlns:a16="http://schemas.microsoft.com/office/drawing/2014/main" id="{6617345F-EEBA-41AC-47F3-FCCDE33CFFE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823070" y="2639889"/>
            <a:ext cx="106433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cal control </a:t>
            </a:r>
            <a:endParaRPr kumimoji="0" lang="ja-JP" altLang="ja-JP" sz="14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0077F06A-B891-A6EF-97B2-26A8724723D5}"/>
              </a:ext>
            </a:extLst>
          </p:cNvPr>
          <p:cNvSpPr txBox="1"/>
          <p:nvPr/>
        </p:nvSpPr>
        <p:spPr>
          <a:xfrm>
            <a:off x="3054426" y="1035081"/>
            <a:ext cx="88605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ja-JP" sz="1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dirty="0"/>
          </a:p>
        </p:txBody>
      </p:sp>
      <p:sp>
        <p:nvSpPr>
          <p:cNvPr id="2" name="Rectangle 54">
            <a:extLst>
              <a:ext uri="{FF2B5EF4-FFF2-40B4-BE49-F238E27FC236}">
                <a16:creationId xmlns:a16="http://schemas.microsoft.com/office/drawing/2014/main" id="{79B25643-14A7-A214-6DC4-80BE9AFB5A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8291" y="4253580"/>
            <a:ext cx="7645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t risk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54758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5E297A5-0857-2EB6-EE9F-A3CE6555061E}"/>
              </a:ext>
            </a:extLst>
          </p:cNvPr>
          <p:cNvSpPr txBox="1"/>
          <p:nvPr/>
        </p:nvSpPr>
        <p:spPr>
          <a:xfrm>
            <a:off x="591424" y="285226"/>
            <a:ext cx="44005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. </a:t>
            </a:r>
            <a:r>
              <a:rPr kumimoji="1"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S according to CEA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28C3BAFB-9A10-2830-9384-3F4361D47084}"/>
              </a:ext>
            </a:extLst>
          </p:cNvPr>
          <p:cNvGrpSpPr/>
          <p:nvPr/>
        </p:nvGrpSpPr>
        <p:grpSpPr>
          <a:xfrm>
            <a:off x="3297553" y="1551355"/>
            <a:ext cx="4472509" cy="3562936"/>
            <a:chOff x="2446842" y="1141922"/>
            <a:chExt cx="4472509" cy="3562936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C4CE2E9D-8D5A-A9BD-D823-4C5B749CAE71}"/>
                </a:ext>
              </a:extLst>
            </p:cNvPr>
            <p:cNvSpPr txBox="1"/>
            <p:nvPr/>
          </p:nvSpPr>
          <p:spPr>
            <a:xfrm>
              <a:off x="5272649" y="2398577"/>
              <a:ext cx="1646702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446</a:t>
              </a:r>
            </a:p>
          </p:txBody>
        </p:sp>
        <p:sp>
          <p:nvSpPr>
            <p:cNvPr id="8" name="Line 5">
              <a:extLst>
                <a:ext uri="{FF2B5EF4-FFF2-40B4-BE49-F238E27FC236}">
                  <a16:creationId xmlns:a16="http://schemas.microsoft.com/office/drawing/2014/main" id="{4EAEC5CB-A5CC-2001-5100-BF91A646FF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5946" y="3761297"/>
              <a:ext cx="273367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5788AA3F-3323-4C53-72B4-D2FB4341F9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5946" y="3761297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7">
              <a:extLst>
                <a:ext uri="{FF2B5EF4-FFF2-40B4-BE49-F238E27FC236}">
                  <a16:creationId xmlns:a16="http://schemas.microsoft.com/office/drawing/2014/main" id="{2C246C2F-9A81-0C6A-F943-72D4BBBAF0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69971" y="3761297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8">
              <a:extLst>
                <a:ext uri="{FF2B5EF4-FFF2-40B4-BE49-F238E27FC236}">
                  <a16:creationId xmlns:a16="http://schemas.microsoft.com/office/drawing/2014/main" id="{3BCD8E70-FE37-B162-2569-DBA5F7942B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25584" y="3761297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9">
              <a:extLst>
                <a:ext uri="{FF2B5EF4-FFF2-40B4-BE49-F238E27FC236}">
                  <a16:creationId xmlns:a16="http://schemas.microsoft.com/office/drawing/2014/main" id="{2FB654A2-0E13-559E-1058-964D164D3C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9609" y="3761297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10">
              <a:extLst>
                <a:ext uri="{FF2B5EF4-FFF2-40B4-BE49-F238E27FC236}">
                  <a16:creationId xmlns:a16="http://schemas.microsoft.com/office/drawing/2014/main" id="{10CBFCEA-8457-8CBC-C87E-8702D65B81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39984" y="3761297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1">
              <a:extLst>
                <a:ext uri="{FF2B5EF4-FFF2-40B4-BE49-F238E27FC236}">
                  <a16:creationId xmlns:a16="http://schemas.microsoft.com/office/drawing/2014/main" id="{83BBF397-B2C2-33BF-EC10-61E6F9491A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5596" y="3761297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2">
              <a:extLst>
                <a:ext uri="{FF2B5EF4-FFF2-40B4-BE49-F238E27FC236}">
                  <a16:creationId xmlns:a16="http://schemas.microsoft.com/office/drawing/2014/main" id="{F13A0185-CD0F-360F-9D57-92FE92A8F6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49621" y="3761297"/>
              <a:ext cx="0" cy="5238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F2766672-3574-5211-DEA2-957EAEE7BC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69909" y="3883535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6C4F3B7A-91D2-0A82-DD59-1C385E7031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5359" y="388353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DF1D1FA0-904A-CD5D-2B39-8C1DA25170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0971" y="388353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86B70C7A-A51D-0CDD-14E6-2776707673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4996" y="388353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4DB2D0A2-7636-4994-78D5-79FE329AC1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5371" y="388353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4E8C7153-3E57-7969-C845-779E912A81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0984" y="388353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ECC72480-CB20-8EC5-C82A-BE340A1B86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5009" y="3883535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20">
              <a:extLst>
                <a:ext uri="{FF2B5EF4-FFF2-40B4-BE49-F238E27FC236}">
                  <a16:creationId xmlns:a16="http://schemas.microsoft.com/office/drawing/2014/main" id="{5F95E588-F41E-AEB0-7A36-2EE4D7B819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4821" y="1241935"/>
              <a:ext cx="0" cy="24193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1">
              <a:extLst>
                <a:ext uri="{FF2B5EF4-FFF2-40B4-BE49-F238E27FC236}">
                  <a16:creationId xmlns:a16="http://schemas.microsoft.com/office/drawing/2014/main" id="{9FD8C867-5EA7-2FA3-5D99-CE97A011AC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46084" y="3661285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2">
              <a:extLst>
                <a:ext uri="{FF2B5EF4-FFF2-40B4-BE49-F238E27FC236}">
                  <a16:creationId xmlns:a16="http://schemas.microsoft.com/office/drawing/2014/main" id="{5C78A10A-D66F-2A84-796C-54084A1D09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46084" y="3177097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3">
              <a:extLst>
                <a:ext uri="{FF2B5EF4-FFF2-40B4-BE49-F238E27FC236}">
                  <a16:creationId xmlns:a16="http://schemas.microsoft.com/office/drawing/2014/main" id="{C7059056-5B5C-140C-AA2A-03D55FC1CE0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46084" y="269291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4">
              <a:extLst>
                <a:ext uri="{FF2B5EF4-FFF2-40B4-BE49-F238E27FC236}">
                  <a16:creationId xmlns:a16="http://schemas.microsoft.com/office/drawing/2014/main" id="{143F7303-6C0C-41CD-E6A5-69E27AC74F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46084" y="221031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5">
              <a:extLst>
                <a:ext uri="{FF2B5EF4-FFF2-40B4-BE49-F238E27FC236}">
                  <a16:creationId xmlns:a16="http://schemas.microsoft.com/office/drawing/2014/main" id="{08332A2C-A931-637C-0B9A-D9237D2E8A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46084" y="1726122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26">
              <a:extLst>
                <a:ext uri="{FF2B5EF4-FFF2-40B4-BE49-F238E27FC236}">
                  <a16:creationId xmlns:a16="http://schemas.microsoft.com/office/drawing/2014/main" id="{7DB1EF68-5E25-263A-EA32-0C635935BF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446084" y="1241935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3ECC678B-FF93-681F-8D71-9BD1E514C5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5945" y="357546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D4D9592C-22BD-2701-7124-0D35DD37FB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5945" y="3091273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6FF60A9A-9A38-70B0-2E1B-371560B975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5945" y="2607085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6C4204C4-E94F-22D5-8CBC-C0B72BCE3D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5945" y="2122898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86C4CE42-0D2F-0DCF-EEBC-FC84DF43FD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5945" y="163871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3A142A27-0883-9FB3-9360-B393BC181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5945" y="1156110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DE8E73EF-45E6-F301-6FF5-097275A45681}"/>
                </a:ext>
              </a:extLst>
            </p:cNvPr>
            <p:cNvSpPr>
              <a:spLocks/>
            </p:cNvSpPr>
            <p:nvPr/>
          </p:nvSpPr>
          <p:spPr bwMode="auto">
            <a:xfrm>
              <a:off x="3504821" y="1141922"/>
              <a:ext cx="3001963" cy="2619375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100F9E79-2E5C-DAAC-9054-73D43013C0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93169" y="3473586"/>
              <a:ext cx="56746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D50AB1BD-2AA3-3F8A-D747-A6A670AE947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918129" y="2355670"/>
              <a:ext cx="19522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</a:t>
              </a: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gression free survival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FAE28DCD-B8E7-514C-4E46-3B32EAB10EC4}"/>
                </a:ext>
              </a:extLst>
            </p:cNvPr>
            <p:cNvSpPr>
              <a:spLocks/>
            </p:cNvSpPr>
            <p:nvPr/>
          </p:nvSpPr>
          <p:spPr bwMode="auto">
            <a:xfrm>
              <a:off x="3615946" y="1241935"/>
              <a:ext cx="2781300" cy="2174875"/>
            </a:xfrm>
            <a:custGeom>
              <a:avLst/>
              <a:gdLst>
                <a:gd name="T0" fmla="*/ 0 w 477"/>
                <a:gd name="T1" fmla="*/ 0 h 373"/>
                <a:gd name="T2" fmla="*/ 8 w 477"/>
                <a:gd name="T3" fmla="*/ 0 h 373"/>
                <a:gd name="T4" fmla="*/ 8 w 477"/>
                <a:gd name="T5" fmla="*/ 4 h 373"/>
                <a:gd name="T6" fmla="*/ 15 w 477"/>
                <a:gd name="T7" fmla="*/ 4 h 373"/>
                <a:gd name="T8" fmla="*/ 15 w 477"/>
                <a:gd name="T9" fmla="*/ 9 h 373"/>
                <a:gd name="T10" fmla="*/ 23 w 477"/>
                <a:gd name="T11" fmla="*/ 9 h 373"/>
                <a:gd name="T12" fmla="*/ 23 w 477"/>
                <a:gd name="T13" fmla="*/ 47 h 373"/>
                <a:gd name="T14" fmla="*/ 31 w 477"/>
                <a:gd name="T15" fmla="*/ 47 h 373"/>
                <a:gd name="T16" fmla="*/ 31 w 477"/>
                <a:gd name="T17" fmla="*/ 61 h 373"/>
                <a:gd name="T18" fmla="*/ 47 w 477"/>
                <a:gd name="T19" fmla="*/ 61 h 373"/>
                <a:gd name="T20" fmla="*/ 47 w 477"/>
                <a:gd name="T21" fmla="*/ 85 h 373"/>
                <a:gd name="T22" fmla="*/ 54 w 477"/>
                <a:gd name="T23" fmla="*/ 85 h 373"/>
                <a:gd name="T24" fmla="*/ 54 w 477"/>
                <a:gd name="T25" fmla="*/ 95 h 373"/>
                <a:gd name="T26" fmla="*/ 62 w 477"/>
                <a:gd name="T27" fmla="*/ 95 h 373"/>
                <a:gd name="T28" fmla="*/ 62 w 477"/>
                <a:gd name="T29" fmla="*/ 110 h 373"/>
                <a:gd name="T30" fmla="*/ 70 w 477"/>
                <a:gd name="T31" fmla="*/ 110 h 373"/>
                <a:gd name="T32" fmla="*/ 70 w 477"/>
                <a:gd name="T33" fmla="*/ 121 h 373"/>
                <a:gd name="T34" fmla="*/ 78 w 477"/>
                <a:gd name="T35" fmla="*/ 121 h 373"/>
                <a:gd name="T36" fmla="*/ 78 w 477"/>
                <a:gd name="T37" fmla="*/ 132 h 373"/>
                <a:gd name="T38" fmla="*/ 86 w 477"/>
                <a:gd name="T39" fmla="*/ 132 h 373"/>
                <a:gd name="T40" fmla="*/ 86 w 477"/>
                <a:gd name="T41" fmla="*/ 156 h 373"/>
                <a:gd name="T42" fmla="*/ 101 w 477"/>
                <a:gd name="T43" fmla="*/ 156 h 373"/>
                <a:gd name="T44" fmla="*/ 101 w 477"/>
                <a:gd name="T45" fmla="*/ 162 h 373"/>
                <a:gd name="T46" fmla="*/ 109 w 477"/>
                <a:gd name="T47" fmla="*/ 162 h 373"/>
                <a:gd name="T48" fmla="*/ 109 w 477"/>
                <a:gd name="T49" fmla="*/ 169 h 373"/>
                <a:gd name="T50" fmla="*/ 117 w 477"/>
                <a:gd name="T51" fmla="*/ 169 h 373"/>
                <a:gd name="T52" fmla="*/ 117 w 477"/>
                <a:gd name="T53" fmla="*/ 184 h 373"/>
                <a:gd name="T54" fmla="*/ 141 w 477"/>
                <a:gd name="T55" fmla="*/ 184 h 373"/>
                <a:gd name="T56" fmla="*/ 141 w 477"/>
                <a:gd name="T57" fmla="*/ 208 h 373"/>
                <a:gd name="T58" fmla="*/ 164 w 477"/>
                <a:gd name="T59" fmla="*/ 208 h 373"/>
                <a:gd name="T60" fmla="*/ 164 w 477"/>
                <a:gd name="T61" fmla="*/ 218 h 373"/>
                <a:gd name="T62" fmla="*/ 180 w 477"/>
                <a:gd name="T63" fmla="*/ 218 h 373"/>
                <a:gd name="T64" fmla="*/ 180 w 477"/>
                <a:gd name="T65" fmla="*/ 229 h 373"/>
                <a:gd name="T66" fmla="*/ 227 w 477"/>
                <a:gd name="T67" fmla="*/ 229 h 373"/>
                <a:gd name="T68" fmla="*/ 227 w 477"/>
                <a:gd name="T69" fmla="*/ 256 h 373"/>
                <a:gd name="T70" fmla="*/ 250 w 477"/>
                <a:gd name="T71" fmla="*/ 256 h 373"/>
                <a:gd name="T72" fmla="*/ 250 w 477"/>
                <a:gd name="T73" fmla="*/ 272 h 373"/>
                <a:gd name="T74" fmla="*/ 258 w 477"/>
                <a:gd name="T75" fmla="*/ 272 h 373"/>
                <a:gd name="T76" fmla="*/ 258 w 477"/>
                <a:gd name="T77" fmla="*/ 288 h 373"/>
                <a:gd name="T78" fmla="*/ 352 w 477"/>
                <a:gd name="T79" fmla="*/ 288 h 373"/>
                <a:gd name="T80" fmla="*/ 352 w 477"/>
                <a:gd name="T81" fmla="*/ 330 h 373"/>
                <a:gd name="T82" fmla="*/ 438 w 477"/>
                <a:gd name="T83" fmla="*/ 330 h 373"/>
                <a:gd name="T84" fmla="*/ 438 w 477"/>
                <a:gd name="T85" fmla="*/ 373 h 373"/>
                <a:gd name="T86" fmla="*/ 477 w 477"/>
                <a:gd name="T87" fmla="*/ 373 h 3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477" h="373">
                  <a:moveTo>
                    <a:pt x="0" y="0"/>
                  </a:moveTo>
                  <a:lnTo>
                    <a:pt x="8" y="0"/>
                  </a:lnTo>
                  <a:lnTo>
                    <a:pt x="8" y="4"/>
                  </a:lnTo>
                  <a:lnTo>
                    <a:pt x="15" y="4"/>
                  </a:lnTo>
                  <a:lnTo>
                    <a:pt x="15" y="9"/>
                  </a:lnTo>
                  <a:lnTo>
                    <a:pt x="23" y="9"/>
                  </a:lnTo>
                  <a:lnTo>
                    <a:pt x="23" y="47"/>
                  </a:lnTo>
                  <a:lnTo>
                    <a:pt x="31" y="47"/>
                  </a:lnTo>
                  <a:lnTo>
                    <a:pt x="31" y="61"/>
                  </a:lnTo>
                  <a:lnTo>
                    <a:pt x="47" y="61"/>
                  </a:lnTo>
                  <a:lnTo>
                    <a:pt x="47" y="85"/>
                  </a:lnTo>
                  <a:lnTo>
                    <a:pt x="54" y="85"/>
                  </a:lnTo>
                  <a:lnTo>
                    <a:pt x="54" y="95"/>
                  </a:lnTo>
                  <a:lnTo>
                    <a:pt x="62" y="95"/>
                  </a:lnTo>
                  <a:lnTo>
                    <a:pt x="62" y="110"/>
                  </a:lnTo>
                  <a:lnTo>
                    <a:pt x="70" y="110"/>
                  </a:lnTo>
                  <a:lnTo>
                    <a:pt x="70" y="121"/>
                  </a:lnTo>
                  <a:lnTo>
                    <a:pt x="78" y="121"/>
                  </a:lnTo>
                  <a:lnTo>
                    <a:pt x="78" y="132"/>
                  </a:lnTo>
                  <a:lnTo>
                    <a:pt x="86" y="132"/>
                  </a:lnTo>
                  <a:lnTo>
                    <a:pt x="86" y="156"/>
                  </a:lnTo>
                  <a:lnTo>
                    <a:pt x="101" y="156"/>
                  </a:lnTo>
                  <a:lnTo>
                    <a:pt x="101" y="162"/>
                  </a:lnTo>
                  <a:lnTo>
                    <a:pt x="109" y="162"/>
                  </a:lnTo>
                  <a:lnTo>
                    <a:pt x="109" y="169"/>
                  </a:lnTo>
                  <a:lnTo>
                    <a:pt x="117" y="169"/>
                  </a:lnTo>
                  <a:lnTo>
                    <a:pt x="117" y="184"/>
                  </a:lnTo>
                  <a:lnTo>
                    <a:pt x="141" y="184"/>
                  </a:lnTo>
                  <a:lnTo>
                    <a:pt x="141" y="208"/>
                  </a:lnTo>
                  <a:lnTo>
                    <a:pt x="164" y="208"/>
                  </a:lnTo>
                  <a:lnTo>
                    <a:pt x="164" y="218"/>
                  </a:lnTo>
                  <a:lnTo>
                    <a:pt x="180" y="218"/>
                  </a:lnTo>
                  <a:lnTo>
                    <a:pt x="180" y="229"/>
                  </a:lnTo>
                  <a:lnTo>
                    <a:pt x="227" y="229"/>
                  </a:lnTo>
                  <a:lnTo>
                    <a:pt x="227" y="256"/>
                  </a:lnTo>
                  <a:lnTo>
                    <a:pt x="250" y="256"/>
                  </a:lnTo>
                  <a:lnTo>
                    <a:pt x="250" y="272"/>
                  </a:lnTo>
                  <a:lnTo>
                    <a:pt x="258" y="272"/>
                  </a:lnTo>
                  <a:lnTo>
                    <a:pt x="258" y="288"/>
                  </a:lnTo>
                  <a:lnTo>
                    <a:pt x="352" y="288"/>
                  </a:lnTo>
                  <a:lnTo>
                    <a:pt x="352" y="330"/>
                  </a:lnTo>
                  <a:lnTo>
                    <a:pt x="438" y="330"/>
                  </a:lnTo>
                  <a:lnTo>
                    <a:pt x="438" y="373"/>
                  </a:lnTo>
                  <a:lnTo>
                    <a:pt x="477" y="373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37">
              <a:extLst>
                <a:ext uri="{FF2B5EF4-FFF2-40B4-BE49-F238E27FC236}">
                  <a16:creationId xmlns:a16="http://schemas.microsoft.com/office/drawing/2014/main" id="{6025ADE5-7437-D3B1-6934-17CE469F8974}"/>
                </a:ext>
              </a:extLst>
            </p:cNvPr>
            <p:cNvSpPr>
              <a:spLocks/>
            </p:cNvSpPr>
            <p:nvPr/>
          </p:nvSpPr>
          <p:spPr bwMode="auto">
            <a:xfrm>
              <a:off x="3615946" y="1241935"/>
              <a:ext cx="1409700" cy="2098675"/>
            </a:xfrm>
            <a:custGeom>
              <a:avLst/>
              <a:gdLst>
                <a:gd name="T0" fmla="*/ 0 w 242"/>
                <a:gd name="T1" fmla="*/ 0 h 360"/>
                <a:gd name="T2" fmla="*/ 8 w 242"/>
                <a:gd name="T3" fmla="*/ 0 h 360"/>
                <a:gd name="T4" fmla="*/ 8 w 242"/>
                <a:gd name="T5" fmla="*/ 7 h 360"/>
                <a:gd name="T6" fmla="*/ 15 w 242"/>
                <a:gd name="T7" fmla="*/ 7 h 360"/>
                <a:gd name="T8" fmla="*/ 15 w 242"/>
                <a:gd name="T9" fmla="*/ 23 h 360"/>
                <a:gd name="T10" fmla="*/ 23 w 242"/>
                <a:gd name="T11" fmla="*/ 23 h 360"/>
                <a:gd name="T12" fmla="*/ 23 w 242"/>
                <a:gd name="T13" fmla="*/ 80 h 360"/>
                <a:gd name="T14" fmla="*/ 31 w 242"/>
                <a:gd name="T15" fmla="*/ 80 h 360"/>
                <a:gd name="T16" fmla="*/ 31 w 242"/>
                <a:gd name="T17" fmla="*/ 124 h 360"/>
                <a:gd name="T18" fmla="*/ 39 w 242"/>
                <a:gd name="T19" fmla="*/ 124 h 360"/>
                <a:gd name="T20" fmla="*/ 39 w 242"/>
                <a:gd name="T21" fmla="*/ 134 h 360"/>
                <a:gd name="T22" fmla="*/ 47 w 242"/>
                <a:gd name="T23" fmla="*/ 134 h 360"/>
                <a:gd name="T24" fmla="*/ 47 w 242"/>
                <a:gd name="T25" fmla="*/ 196 h 360"/>
                <a:gd name="T26" fmla="*/ 62 w 242"/>
                <a:gd name="T27" fmla="*/ 196 h 360"/>
                <a:gd name="T28" fmla="*/ 62 w 242"/>
                <a:gd name="T29" fmla="*/ 218 h 360"/>
                <a:gd name="T30" fmla="*/ 70 w 242"/>
                <a:gd name="T31" fmla="*/ 218 h 360"/>
                <a:gd name="T32" fmla="*/ 70 w 242"/>
                <a:gd name="T33" fmla="*/ 243 h 360"/>
                <a:gd name="T34" fmla="*/ 78 w 242"/>
                <a:gd name="T35" fmla="*/ 243 h 360"/>
                <a:gd name="T36" fmla="*/ 78 w 242"/>
                <a:gd name="T37" fmla="*/ 256 h 360"/>
                <a:gd name="T38" fmla="*/ 94 w 242"/>
                <a:gd name="T39" fmla="*/ 256 h 360"/>
                <a:gd name="T40" fmla="*/ 94 w 242"/>
                <a:gd name="T41" fmla="*/ 270 h 360"/>
                <a:gd name="T42" fmla="*/ 101 w 242"/>
                <a:gd name="T43" fmla="*/ 270 h 360"/>
                <a:gd name="T44" fmla="*/ 101 w 242"/>
                <a:gd name="T45" fmla="*/ 286 h 360"/>
                <a:gd name="T46" fmla="*/ 125 w 242"/>
                <a:gd name="T47" fmla="*/ 286 h 360"/>
                <a:gd name="T48" fmla="*/ 125 w 242"/>
                <a:gd name="T49" fmla="*/ 305 h 360"/>
                <a:gd name="T50" fmla="*/ 156 w 242"/>
                <a:gd name="T51" fmla="*/ 305 h 360"/>
                <a:gd name="T52" fmla="*/ 156 w 242"/>
                <a:gd name="T53" fmla="*/ 360 h 360"/>
                <a:gd name="T54" fmla="*/ 242 w 242"/>
                <a:gd name="T55" fmla="*/ 36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242" h="360">
                  <a:moveTo>
                    <a:pt x="0" y="0"/>
                  </a:moveTo>
                  <a:lnTo>
                    <a:pt x="8" y="0"/>
                  </a:lnTo>
                  <a:lnTo>
                    <a:pt x="8" y="7"/>
                  </a:lnTo>
                  <a:lnTo>
                    <a:pt x="15" y="7"/>
                  </a:lnTo>
                  <a:lnTo>
                    <a:pt x="15" y="23"/>
                  </a:lnTo>
                  <a:lnTo>
                    <a:pt x="23" y="23"/>
                  </a:lnTo>
                  <a:lnTo>
                    <a:pt x="23" y="80"/>
                  </a:lnTo>
                  <a:lnTo>
                    <a:pt x="31" y="80"/>
                  </a:lnTo>
                  <a:lnTo>
                    <a:pt x="31" y="124"/>
                  </a:lnTo>
                  <a:lnTo>
                    <a:pt x="39" y="124"/>
                  </a:lnTo>
                  <a:lnTo>
                    <a:pt x="39" y="134"/>
                  </a:lnTo>
                  <a:lnTo>
                    <a:pt x="47" y="134"/>
                  </a:lnTo>
                  <a:lnTo>
                    <a:pt x="47" y="196"/>
                  </a:lnTo>
                  <a:lnTo>
                    <a:pt x="62" y="196"/>
                  </a:lnTo>
                  <a:lnTo>
                    <a:pt x="62" y="218"/>
                  </a:lnTo>
                  <a:lnTo>
                    <a:pt x="70" y="218"/>
                  </a:lnTo>
                  <a:lnTo>
                    <a:pt x="70" y="243"/>
                  </a:lnTo>
                  <a:lnTo>
                    <a:pt x="78" y="243"/>
                  </a:lnTo>
                  <a:lnTo>
                    <a:pt x="78" y="256"/>
                  </a:lnTo>
                  <a:lnTo>
                    <a:pt x="94" y="256"/>
                  </a:lnTo>
                  <a:lnTo>
                    <a:pt x="94" y="270"/>
                  </a:lnTo>
                  <a:lnTo>
                    <a:pt x="101" y="270"/>
                  </a:lnTo>
                  <a:lnTo>
                    <a:pt x="101" y="286"/>
                  </a:lnTo>
                  <a:lnTo>
                    <a:pt x="125" y="286"/>
                  </a:lnTo>
                  <a:lnTo>
                    <a:pt x="125" y="305"/>
                  </a:lnTo>
                  <a:lnTo>
                    <a:pt x="156" y="305"/>
                  </a:lnTo>
                  <a:lnTo>
                    <a:pt x="156" y="360"/>
                  </a:lnTo>
                  <a:lnTo>
                    <a:pt x="242" y="360"/>
                  </a:lnTo>
                </a:path>
              </a:pathLst>
            </a:cu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5F3B48B5-1127-A468-CAAF-01B7C0D779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1334" y="4209966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1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0086A34C-9ED7-02A6-8866-AF80ABAC9C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5359" y="4209966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F06068D1-74B0-6CFD-6A03-757D8AF7D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0971" y="4209966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44505FA0-A72F-83D9-8F5E-F20B9702B2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4996" y="4209966"/>
              <a:ext cx="16966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FD64FEF9-7263-EA90-EA56-E329BB9C19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3946" y="4209966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5B5C6609-A03B-CCB2-70DB-8CBB26FD40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9559" y="4209966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B4D43456-FBBA-64B2-18D2-005334701D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03584" y="4209966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1CB4360B-FAE4-E05F-0794-6EDC402303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1334" y="448941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7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322541B5-F3C9-A72F-5ACC-EC431BE6B4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5359" y="4489414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64F252ED-42F5-F176-F037-B211E93F6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9546" y="4489414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2AC28D76-EF62-B27C-E4CC-B1EF065294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3571" y="4489414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A0135F58-18BB-F4EF-1AC1-2AEA35EAA6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3946" y="4489414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EB2D8D58-042B-FD03-F118-C97D5277C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9559" y="4489414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2329E74D-FB16-4307-8C88-FFF6353C15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03584" y="4489414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Line 55">
              <a:extLst>
                <a:ext uri="{FF2B5EF4-FFF2-40B4-BE49-F238E27FC236}">
                  <a16:creationId xmlns:a16="http://schemas.microsoft.com/office/drawing/2014/main" id="{AEC20F03-BC5E-1C4E-AEE4-7A09234DEF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63621" y="1673636"/>
              <a:ext cx="168275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56">
              <a:extLst>
                <a:ext uri="{FF2B5EF4-FFF2-40B4-BE49-F238E27FC236}">
                  <a16:creationId xmlns:a16="http://schemas.microsoft.com/office/drawing/2014/main" id="{F47FA87D-DC70-C039-F452-62D707DC19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76636" y="1978975"/>
              <a:ext cx="168275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57">
              <a:extLst>
                <a:ext uri="{FF2B5EF4-FFF2-40B4-BE49-F238E27FC236}">
                  <a16:creationId xmlns:a16="http://schemas.microsoft.com/office/drawing/2014/main" id="{1583F4C3-A95D-66E5-F2DE-D2CF5E9B2B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52542" y="1864486"/>
              <a:ext cx="97077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400" b="1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5 ng/mL </a:t>
              </a:r>
              <a:r>
                <a:rPr lang="en-US" altLang="ja-JP" sz="1400" b="1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≤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57">
              <a:extLst>
                <a:ext uri="{FF2B5EF4-FFF2-40B4-BE49-F238E27FC236}">
                  <a16:creationId xmlns:a16="http://schemas.microsoft.com/office/drawing/2014/main" id="{3F1BFF45-918F-3116-F029-1EA7E8AAD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7085" y="1543373"/>
              <a:ext cx="10174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400" b="1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5 ng/mL &gt;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57">
              <a:extLst>
                <a:ext uri="{FF2B5EF4-FFF2-40B4-BE49-F238E27FC236}">
                  <a16:creationId xmlns:a16="http://schemas.microsoft.com/office/drawing/2014/main" id="{BCBEB8CE-63C0-C0FE-A6AD-A59A6CCB60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6842" y="4485001"/>
              <a:ext cx="97077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400" b="1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5 ng/mL </a:t>
              </a:r>
              <a:r>
                <a:rPr lang="en-US" altLang="ja-JP" sz="1400" b="1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Ｐ明朝" panose="02020600040205080304" pitchFamily="18" charset="-128"/>
                  <a:cs typeface="Times New Roman" panose="02020603050405020304" pitchFamily="18" charset="0"/>
                </a:rPr>
                <a:t>≤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57">
              <a:extLst>
                <a:ext uri="{FF2B5EF4-FFF2-40B4-BE49-F238E27FC236}">
                  <a16:creationId xmlns:a16="http://schemas.microsoft.com/office/drawing/2014/main" id="{8DC5ECDF-B25F-91E1-CD1A-55FA015C5C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7993" y="4200145"/>
              <a:ext cx="10174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400" b="1" i="0" u="none" strike="noStrike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5 ng/mL &gt;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CA2BEFB8-CB17-8188-661F-70CE4D04E43E}"/>
              </a:ext>
            </a:extLst>
          </p:cNvPr>
          <p:cNvSpPr txBox="1"/>
          <p:nvPr/>
        </p:nvSpPr>
        <p:spPr>
          <a:xfrm>
            <a:off x="3274006" y="1131862"/>
            <a:ext cx="508932" cy="3739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dirty="0"/>
          </a:p>
        </p:txBody>
      </p:sp>
      <p:sp>
        <p:nvSpPr>
          <p:cNvPr id="2" name="Rectangle 54">
            <a:extLst>
              <a:ext uri="{FF2B5EF4-FFF2-40B4-BE49-F238E27FC236}">
                <a16:creationId xmlns:a16="http://schemas.microsoft.com/office/drawing/2014/main" id="{858A7E7C-B8CD-8827-A862-BB1EA0C3B5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28332" y="4303451"/>
            <a:ext cx="7645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T</a:t>
            </a:r>
            <a:r>
              <a:rPr kumimoji="0" lang="ja-JP" altLang="ja-JP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t risk</a:t>
            </a:r>
            <a:endParaRPr kumimoji="0" lang="ja-JP" altLang="ja-JP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770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</TotalTime>
  <Words>190</Words>
  <Application>Microsoft Office PowerPoint</Application>
  <PresentationFormat>ワイド画面</PresentationFormat>
  <Paragraphs>111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ewlett-Packard Company</dc:creator>
  <cp:lastModifiedBy>Hewlett-Packard Company</cp:lastModifiedBy>
  <cp:revision>12</cp:revision>
  <cp:lastPrinted>2022-10-31T10:03:37Z</cp:lastPrinted>
  <dcterms:created xsi:type="dcterms:W3CDTF">2022-07-11T01:45:32Z</dcterms:created>
  <dcterms:modified xsi:type="dcterms:W3CDTF">2022-11-28T07:28:01Z</dcterms:modified>
</cp:coreProperties>
</file>